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56" r:id="rId3"/>
    <p:sldId id="266" r:id="rId4"/>
    <p:sldId id="265" r:id="rId5"/>
    <p:sldId id="257" r:id="rId6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2"/>
    <p:restoredTop sz="94648"/>
  </p:normalViewPr>
  <p:slideViewPr>
    <p:cSldViewPr snapToGrid="0" snapToObjects="1">
      <p:cViewPr varScale="1">
        <p:scale>
          <a:sx n="107" d="100"/>
          <a:sy n="107" d="100"/>
        </p:scale>
        <p:origin x="712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2C893FA-516E-CF4C-832E-0C1D293C1E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581542C-0A77-B543-B522-1F2A6F236E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9D4BC39-2885-7C4A-9B6A-A81B14E32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4CB658D-E164-6446-8F6B-504D17B31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BB194AD-84EB-CD44-87EC-0F9CD8F47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8536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E44614-6D6E-FB49-9B14-C66A4FF9B7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7D0704C-7767-2140-83FC-5F03EA0325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057B653-E2CD-C34E-BB09-3D814FB74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1E489B-7808-DC4F-80EC-2CF4FA13D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51D1153-605E-9649-B5F6-C479F79B5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846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18E04980-79D6-CB4B-AAE8-CEF18A493C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DA6B514-538C-7443-AE70-D2D98FCC53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6C7C404-0A83-AA4D-8525-8B621C462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7A6AEC3-FF0A-6342-9D13-BDA9821B4E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5D0E620-FF18-8B44-A203-529964D2A3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8694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826C711-531C-A74F-8CB8-D3A29E7DBE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A34C813-7AAA-3942-9427-2D44516CCD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9EC8A61-4DA9-9743-B533-BE2508422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59191EE-8CBC-D34B-9BA4-E841DD24C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2E88DA5-DA5A-974D-90C4-5D4DFA185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3054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1D0637E-BE7D-5743-8FB5-9142246C7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61EDB29-7A1D-364E-A4D9-76E8B0B001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F573436-F041-D24D-9948-FA29CA4EA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6A02CD2-94AC-C74E-AE71-04A449FBB1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1B65738-4802-884A-9B2A-8BD201DA6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242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10A1970-B039-FC47-A5DF-63EB20103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EA4B0DF-2CBF-C64B-AE5E-00F1510924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4B2E2AE-8B1D-8E41-827E-733B82D4C8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6BB7FA4-9EDC-4A46-B5C6-2E61227EA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C72A31E-5585-694D-9B76-B8B4A948EC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BB922FB-8206-AF4C-A9ED-EC9546796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6614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393CBD6-F5A2-C34E-9EBD-A2578206F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9000DC6-A7E1-3845-9B03-D0DC8F9090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779FA11-54BB-1E46-BFA2-1A91B674D3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06930FDE-BDEB-F04A-83EA-A58760ACA4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901E1D5-427F-CF45-8160-D0E6756AF4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1A0D920-C2DA-7D40-9B32-337F4BE1A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ACEC59B-1905-7F4B-A93B-BA9E5CC94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48EDECC-CD0F-D845-B3E7-10BE8E175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5037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1A7528E-8942-B64B-A99F-2A0872F354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1E5368F-CD97-294A-B6EF-9F1EF6016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FC8D51A-ACC9-984B-8D85-8AB8A8C27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B6DC0F0-CE80-864C-9AFD-DC54014A2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441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B2FE649B-EBC1-C848-BA52-404EBD7CE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042D664-4E28-BC44-A3B5-F82A949B4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D02BCC7-CB97-2E48-97DA-78C0CB63C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6348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8D7151A-7C01-3146-8092-2106D9DC4E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971493-1A91-9248-B96C-7B12DAEC8F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30FDA9B-379B-564A-8671-2ADB8FED57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DF0A96F-D5F2-F141-A4A7-52B8B32B7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93F75F8-0FD3-334D-9967-75A85EF02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8935EFE-AF0A-AB45-835E-4715FB6B9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6651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546BAA0-A9DB-2F47-91DD-E679A1F4CF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0019C5CB-9C11-8246-9EFA-D6C18578F3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A9DB007-2ABE-B94F-B544-FA4B47D362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F88A63D-EE03-B84C-8405-58C851CAD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FB66817-B123-0B4B-87DE-A3AC0BE99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55284EB-DCAB-764B-B608-34D3CEF78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8697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3D33F178-C320-9148-9B6A-60E35B7684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8892333-A256-F54F-8D89-F303F5049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D9B0F2D-5E94-A149-9C24-C089F712DF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CA14F-7315-C648-BB73-DC676F7826B7}" type="datetimeFigureOut">
              <a:rPr lang="fr-FR" smtClean="0"/>
              <a:t>29/07/2019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7F8CDB9-4553-0E46-AC0A-2BB871A279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2B661B9-2D39-4D49-91EB-7874508DD0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857F1-45B6-C84D-AEE2-B70CD29467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1349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space réservé du contenu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1580" y="1495991"/>
            <a:ext cx="8214360" cy="3669555"/>
          </a:xfrm>
        </p:spPr>
      </p:pic>
      <p:cxnSp>
        <p:nvCxnSpPr>
          <p:cNvPr id="7" name="Connecteur droit 6"/>
          <p:cNvCxnSpPr/>
          <p:nvPr/>
        </p:nvCxnSpPr>
        <p:spPr>
          <a:xfrm>
            <a:off x="2399306" y="1594104"/>
            <a:ext cx="15240" cy="32613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necteur droit 8"/>
          <p:cNvCxnSpPr/>
          <p:nvPr/>
        </p:nvCxnSpPr>
        <p:spPr>
          <a:xfrm flipV="1">
            <a:off x="2399306" y="4809744"/>
            <a:ext cx="8625840" cy="457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1507874" y="972771"/>
            <a:ext cx="183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kin </a:t>
            </a:r>
            <a:r>
              <a:rPr lang="fr-FR" sz="1400" dirty="0" err="1"/>
              <a:t>microcirculatory</a:t>
            </a:r>
            <a:r>
              <a:rPr lang="fr-FR" sz="1400" dirty="0"/>
              <a:t> </a:t>
            </a:r>
            <a:r>
              <a:rPr lang="fr-FR" sz="1400" dirty="0" err="1"/>
              <a:t>blood</a:t>
            </a:r>
            <a:r>
              <a:rPr lang="fr-FR" sz="1400" dirty="0"/>
              <a:t> flow (PUs)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2022116" y="1576155"/>
            <a:ext cx="44196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r-FR" sz="1200" dirty="0"/>
          </a:p>
          <a:p>
            <a:r>
              <a:rPr lang="fr-FR" sz="1200" dirty="0"/>
              <a:t>160</a:t>
            </a:r>
          </a:p>
          <a:p>
            <a:endParaRPr lang="fr-FR" sz="1200" dirty="0"/>
          </a:p>
          <a:p>
            <a:r>
              <a:rPr lang="fr-FR" sz="1200" dirty="0"/>
              <a:t>140</a:t>
            </a:r>
          </a:p>
          <a:p>
            <a:endParaRPr lang="fr-FR" sz="1200" dirty="0"/>
          </a:p>
          <a:p>
            <a:r>
              <a:rPr lang="fr-FR" sz="1200" dirty="0"/>
              <a:t>120</a:t>
            </a:r>
          </a:p>
          <a:p>
            <a:endParaRPr lang="fr-FR" sz="1200" dirty="0"/>
          </a:p>
          <a:p>
            <a:r>
              <a:rPr lang="fr-FR" sz="1200" dirty="0"/>
              <a:t>100</a:t>
            </a:r>
          </a:p>
          <a:p>
            <a:endParaRPr lang="fr-FR" sz="1200" dirty="0"/>
          </a:p>
          <a:p>
            <a:r>
              <a:rPr lang="fr-FR" sz="1200" dirty="0"/>
              <a:t>  80</a:t>
            </a:r>
          </a:p>
          <a:p>
            <a:endParaRPr lang="fr-FR" sz="1200" dirty="0"/>
          </a:p>
          <a:p>
            <a:r>
              <a:rPr lang="fr-FR" sz="1200" dirty="0"/>
              <a:t>  60</a:t>
            </a:r>
          </a:p>
          <a:p>
            <a:endParaRPr lang="fr-FR" sz="1200" dirty="0"/>
          </a:p>
          <a:p>
            <a:r>
              <a:rPr lang="fr-FR" sz="1200" dirty="0"/>
              <a:t>  40</a:t>
            </a:r>
          </a:p>
          <a:p>
            <a:endParaRPr lang="fr-FR" sz="1200" dirty="0"/>
          </a:p>
          <a:p>
            <a:r>
              <a:rPr lang="fr-FR" sz="1200" dirty="0"/>
              <a:t>  20</a:t>
            </a:r>
          </a:p>
          <a:p>
            <a:endParaRPr lang="fr-FR" sz="1200" dirty="0"/>
          </a:p>
          <a:p>
            <a:r>
              <a:rPr lang="fr-FR" sz="1200" dirty="0"/>
              <a:t>    0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10730367" y="4877061"/>
            <a:ext cx="1386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Time (minutes)</a:t>
            </a:r>
          </a:p>
        </p:txBody>
      </p:sp>
      <p:sp>
        <p:nvSpPr>
          <p:cNvPr id="14" name="ZoneTexte 13"/>
          <p:cNvSpPr txBox="1"/>
          <p:nvPr/>
        </p:nvSpPr>
        <p:spPr>
          <a:xfrm>
            <a:off x="3844290" y="4923228"/>
            <a:ext cx="83477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               5		 	10	     12	 	15		</a:t>
            </a:r>
          </a:p>
        </p:txBody>
      </p:sp>
      <p:sp>
        <p:nvSpPr>
          <p:cNvPr id="15" name="Triangle 14"/>
          <p:cNvSpPr/>
          <p:nvPr/>
        </p:nvSpPr>
        <p:spPr>
          <a:xfrm flipH="1">
            <a:off x="2700764" y="4917283"/>
            <a:ext cx="247651" cy="21517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solidFill>
                <a:schemeClr val="tx1"/>
              </a:solidFill>
            </a:endParaRPr>
          </a:p>
        </p:txBody>
      </p:sp>
      <p:sp>
        <p:nvSpPr>
          <p:cNvPr id="16" name="Triangle 15"/>
          <p:cNvSpPr/>
          <p:nvPr/>
        </p:nvSpPr>
        <p:spPr>
          <a:xfrm flipH="1">
            <a:off x="3109391" y="4917283"/>
            <a:ext cx="247651" cy="21517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7" name="Triangle 16"/>
          <p:cNvSpPr/>
          <p:nvPr/>
        </p:nvSpPr>
        <p:spPr>
          <a:xfrm flipH="1">
            <a:off x="3518490" y="4901147"/>
            <a:ext cx="247651" cy="21517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cxnSp>
        <p:nvCxnSpPr>
          <p:cNvPr id="26" name="Connecteur droit 25"/>
          <p:cNvCxnSpPr/>
          <p:nvPr/>
        </p:nvCxnSpPr>
        <p:spPr>
          <a:xfrm>
            <a:off x="4487186" y="4855464"/>
            <a:ext cx="0" cy="618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>
            <a:off x="6727466" y="4840223"/>
            <a:ext cx="0" cy="61819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2486204" y="5177738"/>
            <a:ext cx="15697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/>
              <a:t>Acetylcholine</a:t>
            </a:r>
            <a:endParaRPr lang="fr-FR" sz="1600" dirty="0"/>
          </a:p>
        </p:txBody>
      </p:sp>
      <p:cxnSp>
        <p:nvCxnSpPr>
          <p:cNvPr id="31" name="Connecteur droit 30"/>
          <p:cNvCxnSpPr>
            <a:cxnSpLocks/>
          </p:cNvCxnSpPr>
          <p:nvPr/>
        </p:nvCxnSpPr>
        <p:spPr>
          <a:xfrm flipV="1">
            <a:off x="2399306" y="4413504"/>
            <a:ext cx="8625840" cy="113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ZoneTexte 31"/>
          <p:cNvSpPr txBox="1"/>
          <p:nvPr/>
        </p:nvSpPr>
        <p:spPr>
          <a:xfrm>
            <a:off x="728295" y="4225556"/>
            <a:ext cx="1624676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fr-FR" sz="1600" i="1" dirty="0"/>
              <a:t>Basal flow</a:t>
            </a:r>
          </a:p>
        </p:txBody>
      </p:sp>
      <p:cxnSp>
        <p:nvCxnSpPr>
          <p:cNvPr id="39" name="Connecteur droit 38"/>
          <p:cNvCxnSpPr/>
          <p:nvPr/>
        </p:nvCxnSpPr>
        <p:spPr>
          <a:xfrm>
            <a:off x="7849925" y="4827915"/>
            <a:ext cx="0" cy="618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39"/>
          <p:cNvCxnSpPr/>
          <p:nvPr/>
        </p:nvCxnSpPr>
        <p:spPr>
          <a:xfrm>
            <a:off x="9503134" y="4824554"/>
            <a:ext cx="0" cy="618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Forme libre 40"/>
          <p:cNvSpPr/>
          <p:nvPr/>
        </p:nvSpPr>
        <p:spPr>
          <a:xfrm>
            <a:off x="3309068" y="2137443"/>
            <a:ext cx="4572000" cy="2276061"/>
          </a:xfrm>
          <a:custGeom>
            <a:avLst/>
            <a:gdLst>
              <a:gd name="connsiteX0" fmla="*/ 0 w 4572000"/>
              <a:gd name="connsiteY0" fmla="*/ 2276061 h 2276061"/>
              <a:gd name="connsiteX1" fmla="*/ 0 w 4572000"/>
              <a:gd name="connsiteY1" fmla="*/ 2276061 h 2276061"/>
              <a:gd name="connsiteX2" fmla="*/ 9939 w 4572000"/>
              <a:gd name="connsiteY2" fmla="*/ 2156791 h 2276061"/>
              <a:gd name="connsiteX3" fmla="*/ 9939 w 4572000"/>
              <a:gd name="connsiteY3" fmla="*/ 2156791 h 2276061"/>
              <a:gd name="connsiteX4" fmla="*/ 69574 w 4572000"/>
              <a:gd name="connsiteY4" fmla="*/ 2057400 h 2276061"/>
              <a:gd name="connsiteX5" fmla="*/ 79513 w 4572000"/>
              <a:gd name="connsiteY5" fmla="*/ 2176670 h 2276061"/>
              <a:gd name="connsiteX6" fmla="*/ 99391 w 4572000"/>
              <a:gd name="connsiteY6" fmla="*/ 1958009 h 2276061"/>
              <a:gd name="connsiteX7" fmla="*/ 99391 w 4572000"/>
              <a:gd name="connsiteY7" fmla="*/ 1958009 h 2276061"/>
              <a:gd name="connsiteX8" fmla="*/ 99391 w 4572000"/>
              <a:gd name="connsiteY8" fmla="*/ 1958009 h 2276061"/>
              <a:gd name="connsiteX9" fmla="*/ 99391 w 4572000"/>
              <a:gd name="connsiteY9" fmla="*/ 1958009 h 2276061"/>
              <a:gd name="connsiteX10" fmla="*/ 168965 w 4572000"/>
              <a:gd name="connsiteY10" fmla="*/ 2047461 h 2276061"/>
              <a:gd name="connsiteX11" fmla="*/ 129208 w 4572000"/>
              <a:gd name="connsiteY11" fmla="*/ 1967948 h 2276061"/>
              <a:gd name="connsiteX12" fmla="*/ 149087 w 4572000"/>
              <a:gd name="connsiteY12" fmla="*/ 1739348 h 2276061"/>
              <a:gd name="connsiteX13" fmla="*/ 168965 w 4572000"/>
              <a:gd name="connsiteY13" fmla="*/ 1878496 h 2276061"/>
              <a:gd name="connsiteX14" fmla="*/ 188843 w 4572000"/>
              <a:gd name="connsiteY14" fmla="*/ 1580322 h 2276061"/>
              <a:gd name="connsiteX15" fmla="*/ 228600 w 4572000"/>
              <a:gd name="connsiteY15" fmla="*/ 1699591 h 2276061"/>
              <a:gd name="connsiteX16" fmla="*/ 248478 w 4572000"/>
              <a:gd name="connsiteY16" fmla="*/ 1421296 h 2276061"/>
              <a:gd name="connsiteX17" fmla="*/ 258417 w 4572000"/>
              <a:gd name="connsiteY17" fmla="*/ 1659835 h 2276061"/>
              <a:gd name="connsiteX18" fmla="*/ 298174 w 4572000"/>
              <a:gd name="connsiteY18" fmla="*/ 1391478 h 2276061"/>
              <a:gd name="connsiteX19" fmla="*/ 337930 w 4572000"/>
              <a:gd name="connsiteY19" fmla="*/ 1620078 h 2276061"/>
              <a:gd name="connsiteX20" fmla="*/ 337930 w 4572000"/>
              <a:gd name="connsiteY20" fmla="*/ 1262270 h 2276061"/>
              <a:gd name="connsiteX21" fmla="*/ 377687 w 4572000"/>
              <a:gd name="connsiteY21" fmla="*/ 1490870 h 2276061"/>
              <a:gd name="connsiteX22" fmla="*/ 397565 w 4572000"/>
              <a:gd name="connsiteY22" fmla="*/ 1292087 h 2276061"/>
              <a:gd name="connsiteX23" fmla="*/ 427382 w 4572000"/>
              <a:gd name="connsiteY23" fmla="*/ 1421296 h 2276061"/>
              <a:gd name="connsiteX24" fmla="*/ 457200 w 4572000"/>
              <a:gd name="connsiteY24" fmla="*/ 1152939 h 2276061"/>
              <a:gd name="connsiteX25" fmla="*/ 477078 w 4572000"/>
              <a:gd name="connsiteY25" fmla="*/ 1451113 h 2276061"/>
              <a:gd name="connsiteX26" fmla="*/ 496956 w 4572000"/>
              <a:gd name="connsiteY26" fmla="*/ 1113183 h 2276061"/>
              <a:gd name="connsiteX27" fmla="*/ 526774 w 4572000"/>
              <a:gd name="connsiteY27" fmla="*/ 1262270 h 2276061"/>
              <a:gd name="connsiteX28" fmla="*/ 546652 w 4572000"/>
              <a:gd name="connsiteY28" fmla="*/ 954157 h 2276061"/>
              <a:gd name="connsiteX29" fmla="*/ 576469 w 4572000"/>
              <a:gd name="connsiteY29" fmla="*/ 1212574 h 2276061"/>
              <a:gd name="connsiteX30" fmla="*/ 616226 w 4572000"/>
              <a:gd name="connsiteY30" fmla="*/ 894522 h 2276061"/>
              <a:gd name="connsiteX31" fmla="*/ 636104 w 4572000"/>
              <a:gd name="connsiteY31" fmla="*/ 1073426 h 2276061"/>
              <a:gd name="connsiteX32" fmla="*/ 636104 w 4572000"/>
              <a:gd name="connsiteY32" fmla="*/ 894522 h 2276061"/>
              <a:gd name="connsiteX33" fmla="*/ 695739 w 4572000"/>
              <a:gd name="connsiteY33" fmla="*/ 1073426 h 2276061"/>
              <a:gd name="connsiteX34" fmla="*/ 695739 w 4572000"/>
              <a:gd name="connsiteY34" fmla="*/ 824948 h 2276061"/>
              <a:gd name="connsiteX35" fmla="*/ 745435 w 4572000"/>
              <a:gd name="connsiteY35" fmla="*/ 1003852 h 2276061"/>
              <a:gd name="connsiteX36" fmla="*/ 735495 w 4572000"/>
              <a:gd name="connsiteY36" fmla="*/ 655983 h 2276061"/>
              <a:gd name="connsiteX37" fmla="*/ 775252 w 4572000"/>
              <a:gd name="connsiteY37" fmla="*/ 924339 h 2276061"/>
              <a:gd name="connsiteX38" fmla="*/ 785191 w 4572000"/>
              <a:gd name="connsiteY38" fmla="*/ 655983 h 2276061"/>
              <a:gd name="connsiteX39" fmla="*/ 815008 w 4572000"/>
              <a:gd name="connsiteY39" fmla="*/ 834887 h 2276061"/>
              <a:gd name="connsiteX40" fmla="*/ 834887 w 4572000"/>
              <a:gd name="connsiteY40" fmla="*/ 655983 h 2276061"/>
              <a:gd name="connsiteX41" fmla="*/ 844826 w 4572000"/>
              <a:gd name="connsiteY41" fmla="*/ 745435 h 2276061"/>
              <a:gd name="connsiteX42" fmla="*/ 874643 w 4572000"/>
              <a:gd name="connsiteY42" fmla="*/ 596348 h 2276061"/>
              <a:gd name="connsiteX43" fmla="*/ 924339 w 4572000"/>
              <a:gd name="connsiteY43" fmla="*/ 824948 h 2276061"/>
              <a:gd name="connsiteX44" fmla="*/ 934278 w 4572000"/>
              <a:gd name="connsiteY44" fmla="*/ 526774 h 2276061"/>
              <a:gd name="connsiteX45" fmla="*/ 954156 w 4572000"/>
              <a:gd name="connsiteY45" fmla="*/ 745435 h 2276061"/>
              <a:gd name="connsiteX46" fmla="*/ 974035 w 4572000"/>
              <a:gd name="connsiteY46" fmla="*/ 516835 h 2276061"/>
              <a:gd name="connsiteX47" fmla="*/ 983974 w 4572000"/>
              <a:gd name="connsiteY47" fmla="*/ 725557 h 2276061"/>
              <a:gd name="connsiteX48" fmla="*/ 1013791 w 4572000"/>
              <a:gd name="connsiteY48" fmla="*/ 536713 h 2276061"/>
              <a:gd name="connsiteX49" fmla="*/ 1063487 w 4572000"/>
              <a:gd name="connsiteY49" fmla="*/ 626165 h 2276061"/>
              <a:gd name="connsiteX50" fmla="*/ 1063487 w 4572000"/>
              <a:gd name="connsiteY50" fmla="*/ 417444 h 2276061"/>
              <a:gd name="connsiteX51" fmla="*/ 1103243 w 4572000"/>
              <a:gd name="connsiteY51" fmla="*/ 596348 h 2276061"/>
              <a:gd name="connsiteX52" fmla="*/ 1143000 w 4572000"/>
              <a:gd name="connsiteY52" fmla="*/ 457200 h 2276061"/>
              <a:gd name="connsiteX53" fmla="*/ 1172817 w 4572000"/>
              <a:gd name="connsiteY53" fmla="*/ 616226 h 2276061"/>
              <a:gd name="connsiteX54" fmla="*/ 1212574 w 4572000"/>
              <a:gd name="connsiteY54" fmla="*/ 437322 h 2276061"/>
              <a:gd name="connsiteX55" fmla="*/ 1242391 w 4572000"/>
              <a:gd name="connsiteY55" fmla="*/ 556591 h 2276061"/>
              <a:gd name="connsiteX56" fmla="*/ 1262269 w 4572000"/>
              <a:gd name="connsiteY56" fmla="*/ 318052 h 2276061"/>
              <a:gd name="connsiteX57" fmla="*/ 1272208 w 4572000"/>
              <a:gd name="connsiteY57" fmla="*/ 616226 h 2276061"/>
              <a:gd name="connsiteX58" fmla="*/ 1311965 w 4572000"/>
              <a:gd name="connsiteY58" fmla="*/ 347870 h 2276061"/>
              <a:gd name="connsiteX59" fmla="*/ 1331843 w 4572000"/>
              <a:gd name="connsiteY59" fmla="*/ 516835 h 2276061"/>
              <a:gd name="connsiteX60" fmla="*/ 1361661 w 4572000"/>
              <a:gd name="connsiteY60" fmla="*/ 238539 h 2276061"/>
              <a:gd name="connsiteX61" fmla="*/ 1381539 w 4572000"/>
              <a:gd name="connsiteY61" fmla="*/ 566531 h 2276061"/>
              <a:gd name="connsiteX62" fmla="*/ 1401417 w 4572000"/>
              <a:gd name="connsiteY62" fmla="*/ 278296 h 2276061"/>
              <a:gd name="connsiteX63" fmla="*/ 1461052 w 4572000"/>
              <a:gd name="connsiteY63" fmla="*/ 437322 h 2276061"/>
              <a:gd name="connsiteX64" fmla="*/ 1470991 w 4572000"/>
              <a:gd name="connsiteY64" fmla="*/ 238539 h 2276061"/>
              <a:gd name="connsiteX65" fmla="*/ 1490869 w 4572000"/>
              <a:gd name="connsiteY65" fmla="*/ 566531 h 2276061"/>
              <a:gd name="connsiteX66" fmla="*/ 1520687 w 4572000"/>
              <a:gd name="connsiteY66" fmla="*/ 278296 h 2276061"/>
              <a:gd name="connsiteX67" fmla="*/ 1560443 w 4572000"/>
              <a:gd name="connsiteY67" fmla="*/ 496957 h 2276061"/>
              <a:gd name="connsiteX68" fmla="*/ 1580321 w 4572000"/>
              <a:gd name="connsiteY68" fmla="*/ 228600 h 2276061"/>
              <a:gd name="connsiteX69" fmla="*/ 1600200 w 4572000"/>
              <a:gd name="connsiteY69" fmla="*/ 327991 h 2276061"/>
              <a:gd name="connsiteX70" fmla="*/ 1620078 w 4572000"/>
              <a:gd name="connsiteY70" fmla="*/ 0 h 2276061"/>
              <a:gd name="connsiteX71" fmla="*/ 1679713 w 4572000"/>
              <a:gd name="connsiteY71" fmla="*/ 308113 h 2276061"/>
              <a:gd name="connsiteX72" fmla="*/ 1719469 w 4572000"/>
              <a:gd name="connsiteY72" fmla="*/ 79513 h 2276061"/>
              <a:gd name="connsiteX73" fmla="*/ 1749287 w 4572000"/>
              <a:gd name="connsiteY73" fmla="*/ 228600 h 2276061"/>
              <a:gd name="connsiteX74" fmla="*/ 1789043 w 4572000"/>
              <a:gd name="connsiteY74" fmla="*/ 39757 h 2276061"/>
              <a:gd name="connsiteX75" fmla="*/ 1808921 w 4572000"/>
              <a:gd name="connsiteY75" fmla="*/ 288235 h 2276061"/>
              <a:gd name="connsiteX76" fmla="*/ 1818861 w 4572000"/>
              <a:gd name="connsiteY76" fmla="*/ 39757 h 2276061"/>
              <a:gd name="connsiteX77" fmla="*/ 1848678 w 4572000"/>
              <a:gd name="connsiteY77" fmla="*/ 327991 h 2276061"/>
              <a:gd name="connsiteX78" fmla="*/ 1888435 w 4572000"/>
              <a:gd name="connsiteY78" fmla="*/ 49696 h 2276061"/>
              <a:gd name="connsiteX79" fmla="*/ 1918252 w 4572000"/>
              <a:gd name="connsiteY79" fmla="*/ 298174 h 2276061"/>
              <a:gd name="connsiteX80" fmla="*/ 1938130 w 4572000"/>
              <a:gd name="connsiteY80" fmla="*/ 79513 h 2276061"/>
              <a:gd name="connsiteX81" fmla="*/ 1948069 w 4572000"/>
              <a:gd name="connsiteY81" fmla="*/ 327991 h 2276061"/>
              <a:gd name="connsiteX82" fmla="*/ 1967948 w 4572000"/>
              <a:gd name="connsiteY82" fmla="*/ 69574 h 2276061"/>
              <a:gd name="connsiteX83" fmla="*/ 2017643 w 4572000"/>
              <a:gd name="connsiteY83" fmla="*/ 258418 h 2276061"/>
              <a:gd name="connsiteX84" fmla="*/ 2017643 w 4572000"/>
              <a:gd name="connsiteY84" fmla="*/ 39757 h 2276061"/>
              <a:gd name="connsiteX85" fmla="*/ 2047461 w 4572000"/>
              <a:gd name="connsiteY85" fmla="*/ 268357 h 2276061"/>
              <a:gd name="connsiteX86" fmla="*/ 2067339 w 4572000"/>
              <a:gd name="connsiteY86" fmla="*/ 99391 h 2276061"/>
              <a:gd name="connsiteX87" fmla="*/ 2087217 w 4572000"/>
              <a:gd name="connsiteY87" fmla="*/ 327991 h 2276061"/>
              <a:gd name="connsiteX88" fmla="*/ 2117035 w 4572000"/>
              <a:gd name="connsiteY88" fmla="*/ 129209 h 2276061"/>
              <a:gd name="connsiteX89" fmla="*/ 2117035 w 4572000"/>
              <a:gd name="connsiteY89" fmla="*/ 327991 h 2276061"/>
              <a:gd name="connsiteX90" fmla="*/ 2156791 w 4572000"/>
              <a:gd name="connsiteY90" fmla="*/ 79513 h 2276061"/>
              <a:gd name="connsiteX91" fmla="*/ 2196548 w 4572000"/>
              <a:gd name="connsiteY91" fmla="*/ 308113 h 2276061"/>
              <a:gd name="connsiteX92" fmla="*/ 2216426 w 4572000"/>
              <a:gd name="connsiteY92" fmla="*/ 109331 h 2276061"/>
              <a:gd name="connsiteX93" fmla="*/ 2236304 w 4572000"/>
              <a:gd name="connsiteY93" fmla="*/ 357809 h 2276061"/>
              <a:gd name="connsiteX94" fmla="*/ 2256182 w 4572000"/>
              <a:gd name="connsiteY94" fmla="*/ 69574 h 2276061"/>
              <a:gd name="connsiteX95" fmla="*/ 2335695 w 4572000"/>
              <a:gd name="connsiteY95" fmla="*/ 248478 h 2276061"/>
              <a:gd name="connsiteX96" fmla="*/ 2355574 w 4572000"/>
              <a:gd name="connsiteY96" fmla="*/ 119270 h 2276061"/>
              <a:gd name="connsiteX97" fmla="*/ 2385391 w 4572000"/>
              <a:gd name="connsiteY97" fmla="*/ 357809 h 2276061"/>
              <a:gd name="connsiteX98" fmla="*/ 2405269 w 4572000"/>
              <a:gd name="connsiteY98" fmla="*/ 29818 h 2276061"/>
              <a:gd name="connsiteX99" fmla="*/ 2435087 w 4572000"/>
              <a:gd name="connsiteY99" fmla="*/ 367748 h 2276061"/>
              <a:gd name="connsiteX100" fmla="*/ 2435087 w 4572000"/>
              <a:gd name="connsiteY100" fmla="*/ 39757 h 2276061"/>
              <a:gd name="connsiteX101" fmla="*/ 2494721 w 4572000"/>
              <a:gd name="connsiteY101" fmla="*/ 377687 h 2276061"/>
              <a:gd name="connsiteX102" fmla="*/ 2494721 w 4572000"/>
              <a:gd name="connsiteY102" fmla="*/ 119270 h 2276061"/>
              <a:gd name="connsiteX103" fmla="*/ 2534478 w 4572000"/>
              <a:gd name="connsiteY103" fmla="*/ 278296 h 2276061"/>
              <a:gd name="connsiteX104" fmla="*/ 2534478 w 4572000"/>
              <a:gd name="connsiteY104" fmla="*/ 129209 h 2276061"/>
              <a:gd name="connsiteX105" fmla="*/ 2584174 w 4572000"/>
              <a:gd name="connsiteY105" fmla="*/ 248478 h 2276061"/>
              <a:gd name="connsiteX106" fmla="*/ 2584174 w 4572000"/>
              <a:gd name="connsiteY106" fmla="*/ 248478 h 2276061"/>
              <a:gd name="connsiteX107" fmla="*/ 2623930 w 4572000"/>
              <a:gd name="connsiteY107" fmla="*/ 337931 h 2276061"/>
              <a:gd name="connsiteX108" fmla="*/ 2643808 w 4572000"/>
              <a:gd name="connsiteY108" fmla="*/ 119270 h 2276061"/>
              <a:gd name="connsiteX109" fmla="*/ 2643808 w 4572000"/>
              <a:gd name="connsiteY109" fmla="*/ 119270 h 2276061"/>
              <a:gd name="connsiteX110" fmla="*/ 2643808 w 4572000"/>
              <a:gd name="connsiteY110" fmla="*/ 119270 h 2276061"/>
              <a:gd name="connsiteX111" fmla="*/ 2643808 w 4572000"/>
              <a:gd name="connsiteY111" fmla="*/ 119270 h 2276061"/>
              <a:gd name="connsiteX112" fmla="*/ 2673626 w 4572000"/>
              <a:gd name="connsiteY112" fmla="*/ 248478 h 2276061"/>
              <a:gd name="connsiteX113" fmla="*/ 2673626 w 4572000"/>
              <a:gd name="connsiteY113" fmla="*/ 59635 h 2276061"/>
              <a:gd name="connsiteX114" fmla="*/ 2723321 w 4572000"/>
              <a:gd name="connsiteY114" fmla="*/ 248478 h 2276061"/>
              <a:gd name="connsiteX115" fmla="*/ 2723321 w 4572000"/>
              <a:gd name="connsiteY115" fmla="*/ 49696 h 2276061"/>
              <a:gd name="connsiteX116" fmla="*/ 2773017 w 4572000"/>
              <a:gd name="connsiteY116" fmla="*/ 318052 h 2276061"/>
              <a:gd name="connsiteX117" fmla="*/ 2773017 w 4572000"/>
              <a:gd name="connsiteY117" fmla="*/ 79513 h 2276061"/>
              <a:gd name="connsiteX118" fmla="*/ 2802835 w 4572000"/>
              <a:gd name="connsiteY118" fmla="*/ 308113 h 2276061"/>
              <a:gd name="connsiteX119" fmla="*/ 2822713 w 4572000"/>
              <a:gd name="connsiteY119" fmla="*/ 99391 h 2276061"/>
              <a:gd name="connsiteX120" fmla="*/ 2882348 w 4572000"/>
              <a:gd name="connsiteY120" fmla="*/ 308113 h 2276061"/>
              <a:gd name="connsiteX121" fmla="*/ 2862469 w 4572000"/>
              <a:gd name="connsiteY121" fmla="*/ 139148 h 2276061"/>
              <a:gd name="connsiteX122" fmla="*/ 2872408 w 4572000"/>
              <a:gd name="connsiteY122" fmla="*/ 0 h 2276061"/>
              <a:gd name="connsiteX123" fmla="*/ 2922104 w 4572000"/>
              <a:gd name="connsiteY123" fmla="*/ 318052 h 2276061"/>
              <a:gd name="connsiteX124" fmla="*/ 2922104 w 4572000"/>
              <a:gd name="connsiteY124" fmla="*/ 39757 h 2276061"/>
              <a:gd name="connsiteX125" fmla="*/ 2971800 w 4572000"/>
              <a:gd name="connsiteY125" fmla="*/ 337931 h 2276061"/>
              <a:gd name="connsiteX126" fmla="*/ 2971800 w 4572000"/>
              <a:gd name="connsiteY126" fmla="*/ 89452 h 2276061"/>
              <a:gd name="connsiteX127" fmla="*/ 3021495 w 4572000"/>
              <a:gd name="connsiteY127" fmla="*/ 337931 h 2276061"/>
              <a:gd name="connsiteX128" fmla="*/ 3021495 w 4572000"/>
              <a:gd name="connsiteY128" fmla="*/ 79513 h 2276061"/>
              <a:gd name="connsiteX129" fmla="*/ 3051313 w 4572000"/>
              <a:gd name="connsiteY129" fmla="*/ 248478 h 2276061"/>
              <a:gd name="connsiteX130" fmla="*/ 3071191 w 4572000"/>
              <a:gd name="connsiteY130" fmla="*/ 19878 h 2276061"/>
              <a:gd name="connsiteX131" fmla="*/ 3101008 w 4572000"/>
              <a:gd name="connsiteY131" fmla="*/ 337931 h 2276061"/>
              <a:gd name="connsiteX132" fmla="*/ 3120887 w 4572000"/>
              <a:gd name="connsiteY132" fmla="*/ 79513 h 2276061"/>
              <a:gd name="connsiteX133" fmla="*/ 3130826 w 4572000"/>
              <a:gd name="connsiteY133" fmla="*/ 327991 h 2276061"/>
              <a:gd name="connsiteX134" fmla="*/ 3180521 w 4572000"/>
              <a:gd name="connsiteY134" fmla="*/ 119270 h 2276061"/>
              <a:gd name="connsiteX135" fmla="*/ 3180521 w 4572000"/>
              <a:gd name="connsiteY135" fmla="*/ 347870 h 2276061"/>
              <a:gd name="connsiteX136" fmla="*/ 3220278 w 4572000"/>
              <a:gd name="connsiteY136" fmla="*/ 129209 h 2276061"/>
              <a:gd name="connsiteX137" fmla="*/ 3240156 w 4572000"/>
              <a:gd name="connsiteY137" fmla="*/ 397565 h 2276061"/>
              <a:gd name="connsiteX138" fmla="*/ 3260035 w 4572000"/>
              <a:gd name="connsiteY138" fmla="*/ 129209 h 2276061"/>
              <a:gd name="connsiteX139" fmla="*/ 3289852 w 4572000"/>
              <a:gd name="connsiteY139" fmla="*/ 298174 h 2276061"/>
              <a:gd name="connsiteX140" fmla="*/ 3309730 w 4572000"/>
              <a:gd name="connsiteY140" fmla="*/ 168965 h 2276061"/>
              <a:gd name="connsiteX141" fmla="*/ 3329608 w 4572000"/>
              <a:gd name="connsiteY141" fmla="*/ 337931 h 2276061"/>
              <a:gd name="connsiteX142" fmla="*/ 3369365 w 4572000"/>
              <a:gd name="connsiteY142" fmla="*/ 188844 h 2276061"/>
              <a:gd name="connsiteX143" fmla="*/ 3379304 w 4572000"/>
              <a:gd name="connsiteY143" fmla="*/ 397565 h 2276061"/>
              <a:gd name="connsiteX144" fmla="*/ 3399182 w 4572000"/>
              <a:gd name="connsiteY144" fmla="*/ 178904 h 2276061"/>
              <a:gd name="connsiteX145" fmla="*/ 3429000 w 4572000"/>
              <a:gd name="connsiteY145" fmla="*/ 397565 h 2276061"/>
              <a:gd name="connsiteX146" fmla="*/ 3448878 w 4572000"/>
              <a:gd name="connsiteY146" fmla="*/ 178904 h 2276061"/>
              <a:gd name="connsiteX147" fmla="*/ 3478695 w 4572000"/>
              <a:gd name="connsiteY147" fmla="*/ 407504 h 2276061"/>
              <a:gd name="connsiteX148" fmla="*/ 3508513 w 4572000"/>
              <a:gd name="connsiteY148" fmla="*/ 178904 h 2276061"/>
              <a:gd name="connsiteX149" fmla="*/ 3518452 w 4572000"/>
              <a:gd name="connsiteY149" fmla="*/ 387626 h 2276061"/>
              <a:gd name="connsiteX150" fmla="*/ 3558208 w 4572000"/>
              <a:gd name="connsiteY150" fmla="*/ 268357 h 2276061"/>
              <a:gd name="connsiteX151" fmla="*/ 3578087 w 4572000"/>
              <a:gd name="connsiteY151" fmla="*/ 506896 h 2276061"/>
              <a:gd name="connsiteX152" fmla="*/ 3597965 w 4572000"/>
              <a:gd name="connsiteY152" fmla="*/ 238539 h 2276061"/>
              <a:gd name="connsiteX153" fmla="*/ 3617843 w 4572000"/>
              <a:gd name="connsiteY153" fmla="*/ 457200 h 2276061"/>
              <a:gd name="connsiteX154" fmla="*/ 3647661 w 4572000"/>
              <a:gd name="connsiteY154" fmla="*/ 168965 h 2276061"/>
              <a:gd name="connsiteX155" fmla="*/ 3677478 w 4572000"/>
              <a:gd name="connsiteY155" fmla="*/ 467139 h 2276061"/>
              <a:gd name="connsiteX156" fmla="*/ 3697356 w 4572000"/>
              <a:gd name="connsiteY156" fmla="*/ 218661 h 2276061"/>
              <a:gd name="connsiteX157" fmla="*/ 3737113 w 4572000"/>
              <a:gd name="connsiteY157" fmla="*/ 506896 h 2276061"/>
              <a:gd name="connsiteX158" fmla="*/ 3756991 w 4572000"/>
              <a:gd name="connsiteY158" fmla="*/ 298174 h 2276061"/>
              <a:gd name="connsiteX159" fmla="*/ 3786808 w 4572000"/>
              <a:gd name="connsiteY159" fmla="*/ 526774 h 2276061"/>
              <a:gd name="connsiteX160" fmla="*/ 3786808 w 4572000"/>
              <a:gd name="connsiteY160" fmla="*/ 327991 h 2276061"/>
              <a:gd name="connsiteX161" fmla="*/ 3826565 w 4572000"/>
              <a:gd name="connsiteY161" fmla="*/ 536713 h 2276061"/>
              <a:gd name="connsiteX162" fmla="*/ 3846443 w 4572000"/>
              <a:gd name="connsiteY162" fmla="*/ 308113 h 2276061"/>
              <a:gd name="connsiteX163" fmla="*/ 3876261 w 4572000"/>
              <a:gd name="connsiteY163" fmla="*/ 566531 h 2276061"/>
              <a:gd name="connsiteX164" fmla="*/ 3896139 w 4572000"/>
              <a:gd name="connsiteY164" fmla="*/ 298174 h 2276061"/>
              <a:gd name="connsiteX165" fmla="*/ 3925956 w 4572000"/>
              <a:gd name="connsiteY165" fmla="*/ 546652 h 2276061"/>
              <a:gd name="connsiteX166" fmla="*/ 3925956 w 4572000"/>
              <a:gd name="connsiteY166" fmla="*/ 298174 h 2276061"/>
              <a:gd name="connsiteX167" fmla="*/ 3955774 w 4572000"/>
              <a:gd name="connsiteY167" fmla="*/ 586409 h 2276061"/>
              <a:gd name="connsiteX168" fmla="*/ 3975652 w 4572000"/>
              <a:gd name="connsiteY168" fmla="*/ 337931 h 2276061"/>
              <a:gd name="connsiteX169" fmla="*/ 4005469 w 4572000"/>
              <a:gd name="connsiteY169" fmla="*/ 626165 h 2276061"/>
              <a:gd name="connsiteX170" fmla="*/ 4015408 w 4572000"/>
              <a:gd name="connsiteY170" fmla="*/ 337931 h 2276061"/>
              <a:gd name="connsiteX171" fmla="*/ 4045226 w 4572000"/>
              <a:gd name="connsiteY171" fmla="*/ 646044 h 2276061"/>
              <a:gd name="connsiteX172" fmla="*/ 4065104 w 4572000"/>
              <a:gd name="connsiteY172" fmla="*/ 367748 h 2276061"/>
              <a:gd name="connsiteX173" fmla="*/ 4094921 w 4572000"/>
              <a:gd name="connsiteY173" fmla="*/ 596348 h 2276061"/>
              <a:gd name="connsiteX174" fmla="*/ 4104861 w 4572000"/>
              <a:gd name="connsiteY174" fmla="*/ 347870 h 2276061"/>
              <a:gd name="connsiteX175" fmla="*/ 4134678 w 4572000"/>
              <a:gd name="connsiteY175" fmla="*/ 566531 h 2276061"/>
              <a:gd name="connsiteX176" fmla="*/ 4154556 w 4572000"/>
              <a:gd name="connsiteY176" fmla="*/ 387626 h 2276061"/>
              <a:gd name="connsiteX177" fmla="*/ 4214191 w 4572000"/>
              <a:gd name="connsiteY177" fmla="*/ 805070 h 2276061"/>
              <a:gd name="connsiteX178" fmla="*/ 4253948 w 4572000"/>
              <a:gd name="connsiteY178" fmla="*/ 477078 h 2276061"/>
              <a:gd name="connsiteX179" fmla="*/ 4283765 w 4572000"/>
              <a:gd name="connsiteY179" fmla="*/ 685800 h 2276061"/>
              <a:gd name="connsiteX180" fmla="*/ 4313582 w 4572000"/>
              <a:gd name="connsiteY180" fmla="*/ 477078 h 2276061"/>
              <a:gd name="connsiteX181" fmla="*/ 4333461 w 4572000"/>
              <a:gd name="connsiteY181" fmla="*/ 755374 h 2276061"/>
              <a:gd name="connsiteX182" fmla="*/ 4373217 w 4572000"/>
              <a:gd name="connsiteY182" fmla="*/ 487018 h 2276061"/>
              <a:gd name="connsiteX183" fmla="*/ 4383156 w 4572000"/>
              <a:gd name="connsiteY183" fmla="*/ 815009 h 2276061"/>
              <a:gd name="connsiteX184" fmla="*/ 4403035 w 4572000"/>
              <a:gd name="connsiteY184" fmla="*/ 487018 h 2276061"/>
              <a:gd name="connsiteX185" fmla="*/ 4442791 w 4572000"/>
              <a:gd name="connsiteY185" fmla="*/ 805070 h 2276061"/>
              <a:gd name="connsiteX186" fmla="*/ 4452730 w 4572000"/>
              <a:gd name="connsiteY186" fmla="*/ 566531 h 2276061"/>
              <a:gd name="connsiteX187" fmla="*/ 4492487 w 4572000"/>
              <a:gd name="connsiteY187" fmla="*/ 705678 h 2276061"/>
              <a:gd name="connsiteX188" fmla="*/ 4512365 w 4572000"/>
              <a:gd name="connsiteY188" fmla="*/ 546652 h 2276061"/>
              <a:gd name="connsiteX189" fmla="*/ 4542182 w 4572000"/>
              <a:gd name="connsiteY189" fmla="*/ 834887 h 2276061"/>
              <a:gd name="connsiteX190" fmla="*/ 4552121 w 4572000"/>
              <a:gd name="connsiteY190" fmla="*/ 516835 h 2276061"/>
              <a:gd name="connsiteX191" fmla="*/ 4572000 w 4572000"/>
              <a:gd name="connsiteY191" fmla="*/ 2276061 h 2276061"/>
              <a:gd name="connsiteX192" fmla="*/ 0 w 4572000"/>
              <a:gd name="connsiteY192" fmla="*/ 2276061 h 22760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</a:cxnLst>
            <a:rect l="l" t="t" r="r" b="b"/>
            <a:pathLst>
              <a:path w="4572000" h="2276061">
                <a:moveTo>
                  <a:pt x="0" y="2276061"/>
                </a:moveTo>
                <a:lnTo>
                  <a:pt x="0" y="2276061"/>
                </a:lnTo>
                <a:lnTo>
                  <a:pt x="9939" y="2156791"/>
                </a:lnTo>
                <a:lnTo>
                  <a:pt x="9939" y="2156791"/>
                </a:lnTo>
                <a:lnTo>
                  <a:pt x="69574" y="2057400"/>
                </a:lnTo>
                <a:lnTo>
                  <a:pt x="79513" y="2176670"/>
                </a:lnTo>
                <a:lnTo>
                  <a:pt x="99391" y="1958009"/>
                </a:lnTo>
                <a:lnTo>
                  <a:pt x="99391" y="1958009"/>
                </a:lnTo>
                <a:lnTo>
                  <a:pt x="99391" y="1958009"/>
                </a:lnTo>
                <a:lnTo>
                  <a:pt x="99391" y="1958009"/>
                </a:lnTo>
                <a:lnTo>
                  <a:pt x="168965" y="2047461"/>
                </a:lnTo>
                <a:lnTo>
                  <a:pt x="129208" y="1967948"/>
                </a:lnTo>
                <a:lnTo>
                  <a:pt x="149087" y="1739348"/>
                </a:lnTo>
                <a:lnTo>
                  <a:pt x="168965" y="1878496"/>
                </a:lnTo>
                <a:lnTo>
                  <a:pt x="188843" y="1580322"/>
                </a:lnTo>
                <a:lnTo>
                  <a:pt x="228600" y="1699591"/>
                </a:lnTo>
                <a:lnTo>
                  <a:pt x="248478" y="1421296"/>
                </a:lnTo>
                <a:lnTo>
                  <a:pt x="258417" y="1659835"/>
                </a:lnTo>
                <a:lnTo>
                  <a:pt x="298174" y="1391478"/>
                </a:lnTo>
                <a:lnTo>
                  <a:pt x="337930" y="1620078"/>
                </a:lnTo>
                <a:lnTo>
                  <a:pt x="337930" y="1262270"/>
                </a:lnTo>
                <a:lnTo>
                  <a:pt x="377687" y="1490870"/>
                </a:lnTo>
                <a:lnTo>
                  <a:pt x="397565" y="1292087"/>
                </a:lnTo>
                <a:lnTo>
                  <a:pt x="427382" y="1421296"/>
                </a:lnTo>
                <a:lnTo>
                  <a:pt x="457200" y="1152939"/>
                </a:lnTo>
                <a:lnTo>
                  <a:pt x="477078" y="1451113"/>
                </a:lnTo>
                <a:lnTo>
                  <a:pt x="496956" y="1113183"/>
                </a:lnTo>
                <a:lnTo>
                  <a:pt x="526774" y="1262270"/>
                </a:lnTo>
                <a:lnTo>
                  <a:pt x="546652" y="954157"/>
                </a:lnTo>
                <a:lnTo>
                  <a:pt x="576469" y="1212574"/>
                </a:lnTo>
                <a:lnTo>
                  <a:pt x="616226" y="894522"/>
                </a:lnTo>
                <a:lnTo>
                  <a:pt x="636104" y="1073426"/>
                </a:lnTo>
                <a:lnTo>
                  <a:pt x="636104" y="894522"/>
                </a:lnTo>
                <a:lnTo>
                  <a:pt x="695739" y="1073426"/>
                </a:lnTo>
                <a:lnTo>
                  <a:pt x="695739" y="824948"/>
                </a:lnTo>
                <a:lnTo>
                  <a:pt x="745435" y="1003852"/>
                </a:lnTo>
                <a:lnTo>
                  <a:pt x="735495" y="655983"/>
                </a:lnTo>
                <a:lnTo>
                  <a:pt x="775252" y="924339"/>
                </a:lnTo>
                <a:lnTo>
                  <a:pt x="785191" y="655983"/>
                </a:lnTo>
                <a:lnTo>
                  <a:pt x="815008" y="834887"/>
                </a:lnTo>
                <a:lnTo>
                  <a:pt x="834887" y="655983"/>
                </a:lnTo>
                <a:lnTo>
                  <a:pt x="844826" y="745435"/>
                </a:lnTo>
                <a:lnTo>
                  <a:pt x="874643" y="596348"/>
                </a:lnTo>
                <a:lnTo>
                  <a:pt x="924339" y="824948"/>
                </a:lnTo>
                <a:lnTo>
                  <a:pt x="934278" y="526774"/>
                </a:lnTo>
                <a:lnTo>
                  <a:pt x="954156" y="745435"/>
                </a:lnTo>
                <a:lnTo>
                  <a:pt x="974035" y="516835"/>
                </a:lnTo>
                <a:lnTo>
                  <a:pt x="983974" y="725557"/>
                </a:lnTo>
                <a:lnTo>
                  <a:pt x="1013791" y="536713"/>
                </a:lnTo>
                <a:lnTo>
                  <a:pt x="1063487" y="626165"/>
                </a:lnTo>
                <a:lnTo>
                  <a:pt x="1063487" y="417444"/>
                </a:lnTo>
                <a:lnTo>
                  <a:pt x="1103243" y="596348"/>
                </a:lnTo>
                <a:lnTo>
                  <a:pt x="1143000" y="457200"/>
                </a:lnTo>
                <a:lnTo>
                  <a:pt x="1172817" y="616226"/>
                </a:lnTo>
                <a:lnTo>
                  <a:pt x="1212574" y="437322"/>
                </a:lnTo>
                <a:lnTo>
                  <a:pt x="1242391" y="556591"/>
                </a:lnTo>
                <a:lnTo>
                  <a:pt x="1262269" y="318052"/>
                </a:lnTo>
                <a:lnTo>
                  <a:pt x="1272208" y="616226"/>
                </a:lnTo>
                <a:lnTo>
                  <a:pt x="1311965" y="347870"/>
                </a:lnTo>
                <a:lnTo>
                  <a:pt x="1331843" y="516835"/>
                </a:lnTo>
                <a:lnTo>
                  <a:pt x="1361661" y="238539"/>
                </a:lnTo>
                <a:lnTo>
                  <a:pt x="1381539" y="566531"/>
                </a:lnTo>
                <a:lnTo>
                  <a:pt x="1401417" y="278296"/>
                </a:lnTo>
                <a:lnTo>
                  <a:pt x="1461052" y="437322"/>
                </a:lnTo>
                <a:lnTo>
                  <a:pt x="1470991" y="238539"/>
                </a:lnTo>
                <a:lnTo>
                  <a:pt x="1490869" y="566531"/>
                </a:lnTo>
                <a:lnTo>
                  <a:pt x="1520687" y="278296"/>
                </a:lnTo>
                <a:lnTo>
                  <a:pt x="1560443" y="496957"/>
                </a:lnTo>
                <a:lnTo>
                  <a:pt x="1580321" y="228600"/>
                </a:lnTo>
                <a:lnTo>
                  <a:pt x="1600200" y="327991"/>
                </a:lnTo>
                <a:lnTo>
                  <a:pt x="1620078" y="0"/>
                </a:lnTo>
                <a:lnTo>
                  <a:pt x="1679713" y="308113"/>
                </a:lnTo>
                <a:lnTo>
                  <a:pt x="1719469" y="79513"/>
                </a:lnTo>
                <a:lnTo>
                  <a:pt x="1749287" y="228600"/>
                </a:lnTo>
                <a:lnTo>
                  <a:pt x="1789043" y="39757"/>
                </a:lnTo>
                <a:lnTo>
                  <a:pt x="1808921" y="288235"/>
                </a:lnTo>
                <a:lnTo>
                  <a:pt x="1818861" y="39757"/>
                </a:lnTo>
                <a:lnTo>
                  <a:pt x="1848678" y="327991"/>
                </a:lnTo>
                <a:lnTo>
                  <a:pt x="1888435" y="49696"/>
                </a:lnTo>
                <a:lnTo>
                  <a:pt x="1918252" y="298174"/>
                </a:lnTo>
                <a:lnTo>
                  <a:pt x="1938130" y="79513"/>
                </a:lnTo>
                <a:lnTo>
                  <a:pt x="1948069" y="327991"/>
                </a:lnTo>
                <a:lnTo>
                  <a:pt x="1967948" y="69574"/>
                </a:lnTo>
                <a:lnTo>
                  <a:pt x="2017643" y="258418"/>
                </a:lnTo>
                <a:lnTo>
                  <a:pt x="2017643" y="39757"/>
                </a:lnTo>
                <a:lnTo>
                  <a:pt x="2047461" y="268357"/>
                </a:lnTo>
                <a:lnTo>
                  <a:pt x="2067339" y="99391"/>
                </a:lnTo>
                <a:lnTo>
                  <a:pt x="2087217" y="327991"/>
                </a:lnTo>
                <a:lnTo>
                  <a:pt x="2117035" y="129209"/>
                </a:lnTo>
                <a:lnTo>
                  <a:pt x="2117035" y="327991"/>
                </a:lnTo>
                <a:lnTo>
                  <a:pt x="2156791" y="79513"/>
                </a:lnTo>
                <a:lnTo>
                  <a:pt x="2196548" y="308113"/>
                </a:lnTo>
                <a:lnTo>
                  <a:pt x="2216426" y="109331"/>
                </a:lnTo>
                <a:lnTo>
                  <a:pt x="2236304" y="357809"/>
                </a:lnTo>
                <a:lnTo>
                  <a:pt x="2256182" y="69574"/>
                </a:lnTo>
                <a:lnTo>
                  <a:pt x="2335695" y="248478"/>
                </a:lnTo>
                <a:lnTo>
                  <a:pt x="2355574" y="119270"/>
                </a:lnTo>
                <a:lnTo>
                  <a:pt x="2385391" y="357809"/>
                </a:lnTo>
                <a:lnTo>
                  <a:pt x="2405269" y="29818"/>
                </a:lnTo>
                <a:lnTo>
                  <a:pt x="2435087" y="367748"/>
                </a:lnTo>
                <a:lnTo>
                  <a:pt x="2435087" y="39757"/>
                </a:lnTo>
                <a:lnTo>
                  <a:pt x="2494721" y="377687"/>
                </a:lnTo>
                <a:lnTo>
                  <a:pt x="2494721" y="119270"/>
                </a:lnTo>
                <a:lnTo>
                  <a:pt x="2534478" y="278296"/>
                </a:lnTo>
                <a:lnTo>
                  <a:pt x="2534478" y="129209"/>
                </a:lnTo>
                <a:lnTo>
                  <a:pt x="2584174" y="248478"/>
                </a:lnTo>
                <a:lnTo>
                  <a:pt x="2584174" y="248478"/>
                </a:lnTo>
                <a:lnTo>
                  <a:pt x="2623930" y="337931"/>
                </a:lnTo>
                <a:lnTo>
                  <a:pt x="2643808" y="119270"/>
                </a:lnTo>
                <a:lnTo>
                  <a:pt x="2643808" y="119270"/>
                </a:lnTo>
                <a:lnTo>
                  <a:pt x="2643808" y="119270"/>
                </a:lnTo>
                <a:lnTo>
                  <a:pt x="2643808" y="119270"/>
                </a:lnTo>
                <a:lnTo>
                  <a:pt x="2673626" y="248478"/>
                </a:lnTo>
                <a:lnTo>
                  <a:pt x="2673626" y="59635"/>
                </a:lnTo>
                <a:lnTo>
                  <a:pt x="2723321" y="248478"/>
                </a:lnTo>
                <a:lnTo>
                  <a:pt x="2723321" y="49696"/>
                </a:lnTo>
                <a:lnTo>
                  <a:pt x="2773017" y="318052"/>
                </a:lnTo>
                <a:lnTo>
                  <a:pt x="2773017" y="79513"/>
                </a:lnTo>
                <a:lnTo>
                  <a:pt x="2802835" y="308113"/>
                </a:lnTo>
                <a:lnTo>
                  <a:pt x="2822713" y="99391"/>
                </a:lnTo>
                <a:lnTo>
                  <a:pt x="2882348" y="308113"/>
                </a:lnTo>
                <a:lnTo>
                  <a:pt x="2862469" y="139148"/>
                </a:lnTo>
                <a:lnTo>
                  <a:pt x="2872408" y="0"/>
                </a:lnTo>
                <a:lnTo>
                  <a:pt x="2922104" y="318052"/>
                </a:lnTo>
                <a:lnTo>
                  <a:pt x="2922104" y="39757"/>
                </a:lnTo>
                <a:lnTo>
                  <a:pt x="2971800" y="337931"/>
                </a:lnTo>
                <a:lnTo>
                  <a:pt x="2971800" y="89452"/>
                </a:lnTo>
                <a:lnTo>
                  <a:pt x="3021495" y="337931"/>
                </a:lnTo>
                <a:lnTo>
                  <a:pt x="3021495" y="79513"/>
                </a:lnTo>
                <a:lnTo>
                  <a:pt x="3051313" y="248478"/>
                </a:lnTo>
                <a:lnTo>
                  <a:pt x="3071191" y="19878"/>
                </a:lnTo>
                <a:lnTo>
                  <a:pt x="3101008" y="337931"/>
                </a:lnTo>
                <a:lnTo>
                  <a:pt x="3120887" y="79513"/>
                </a:lnTo>
                <a:lnTo>
                  <a:pt x="3130826" y="327991"/>
                </a:lnTo>
                <a:lnTo>
                  <a:pt x="3180521" y="119270"/>
                </a:lnTo>
                <a:lnTo>
                  <a:pt x="3180521" y="347870"/>
                </a:lnTo>
                <a:lnTo>
                  <a:pt x="3220278" y="129209"/>
                </a:lnTo>
                <a:lnTo>
                  <a:pt x="3240156" y="397565"/>
                </a:lnTo>
                <a:lnTo>
                  <a:pt x="3260035" y="129209"/>
                </a:lnTo>
                <a:lnTo>
                  <a:pt x="3289852" y="298174"/>
                </a:lnTo>
                <a:lnTo>
                  <a:pt x="3309730" y="168965"/>
                </a:lnTo>
                <a:lnTo>
                  <a:pt x="3329608" y="337931"/>
                </a:lnTo>
                <a:lnTo>
                  <a:pt x="3369365" y="188844"/>
                </a:lnTo>
                <a:lnTo>
                  <a:pt x="3379304" y="397565"/>
                </a:lnTo>
                <a:lnTo>
                  <a:pt x="3399182" y="178904"/>
                </a:lnTo>
                <a:lnTo>
                  <a:pt x="3429000" y="397565"/>
                </a:lnTo>
                <a:lnTo>
                  <a:pt x="3448878" y="178904"/>
                </a:lnTo>
                <a:lnTo>
                  <a:pt x="3478695" y="407504"/>
                </a:lnTo>
                <a:lnTo>
                  <a:pt x="3508513" y="178904"/>
                </a:lnTo>
                <a:lnTo>
                  <a:pt x="3518452" y="387626"/>
                </a:lnTo>
                <a:lnTo>
                  <a:pt x="3558208" y="268357"/>
                </a:lnTo>
                <a:lnTo>
                  <a:pt x="3578087" y="506896"/>
                </a:lnTo>
                <a:lnTo>
                  <a:pt x="3597965" y="238539"/>
                </a:lnTo>
                <a:lnTo>
                  <a:pt x="3617843" y="457200"/>
                </a:lnTo>
                <a:lnTo>
                  <a:pt x="3647661" y="168965"/>
                </a:lnTo>
                <a:lnTo>
                  <a:pt x="3677478" y="467139"/>
                </a:lnTo>
                <a:lnTo>
                  <a:pt x="3697356" y="218661"/>
                </a:lnTo>
                <a:lnTo>
                  <a:pt x="3737113" y="506896"/>
                </a:lnTo>
                <a:lnTo>
                  <a:pt x="3756991" y="298174"/>
                </a:lnTo>
                <a:lnTo>
                  <a:pt x="3786808" y="526774"/>
                </a:lnTo>
                <a:lnTo>
                  <a:pt x="3786808" y="327991"/>
                </a:lnTo>
                <a:lnTo>
                  <a:pt x="3826565" y="536713"/>
                </a:lnTo>
                <a:lnTo>
                  <a:pt x="3846443" y="308113"/>
                </a:lnTo>
                <a:lnTo>
                  <a:pt x="3876261" y="566531"/>
                </a:lnTo>
                <a:lnTo>
                  <a:pt x="3896139" y="298174"/>
                </a:lnTo>
                <a:lnTo>
                  <a:pt x="3925956" y="546652"/>
                </a:lnTo>
                <a:lnTo>
                  <a:pt x="3925956" y="298174"/>
                </a:lnTo>
                <a:lnTo>
                  <a:pt x="3955774" y="586409"/>
                </a:lnTo>
                <a:lnTo>
                  <a:pt x="3975652" y="337931"/>
                </a:lnTo>
                <a:lnTo>
                  <a:pt x="4005469" y="626165"/>
                </a:lnTo>
                <a:lnTo>
                  <a:pt x="4015408" y="337931"/>
                </a:lnTo>
                <a:lnTo>
                  <a:pt x="4045226" y="646044"/>
                </a:lnTo>
                <a:lnTo>
                  <a:pt x="4065104" y="367748"/>
                </a:lnTo>
                <a:lnTo>
                  <a:pt x="4094921" y="596348"/>
                </a:lnTo>
                <a:lnTo>
                  <a:pt x="4104861" y="347870"/>
                </a:lnTo>
                <a:lnTo>
                  <a:pt x="4134678" y="566531"/>
                </a:lnTo>
                <a:lnTo>
                  <a:pt x="4154556" y="387626"/>
                </a:lnTo>
                <a:lnTo>
                  <a:pt x="4214191" y="805070"/>
                </a:lnTo>
                <a:lnTo>
                  <a:pt x="4253948" y="477078"/>
                </a:lnTo>
                <a:lnTo>
                  <a:pt x="4283765" y="685800"/>
                </a:lnTo>
                <a:lnTo>
                  <a:pt x="4313582" y="477078"/>
                </a:lnTo>
                <a:lnTo>
                  <a:pt x="4333461" y="755374"/>
                </a:lnTo>
                <a:lnTo>
                  <a:pt x="4373217" y="487018"/>
                </a:lnTo>
                <a:lnTo>
                  <a:pt x="4383156" y="815009"/>
                </a:lnTo>
                <a:lnTo>
                  <a:pt x="4403035" y="487018"/>
                </a:lnTo>
                <a:lnTo>
                  <a:pt x="4442791" y="805070"/>
                </a:lnTo>
                <a:lnTo>
                  <a:pt x="4452730" y="566531"/>
                </a:lnTo>
                <a:lnTo>
                  <a:pt x="4492487" y="705678"/>
                </a:lnTo>
                <a:lnTo>
                  <a:pt x="4512365" y="546652"/>
                </a:lnTo>
                <a:lnTo>
                  <a:pt x="4542182" y="834887"/>
                </a:lnTo>
                <a:lnTo>
                  <a:pt x="4552121" y="516835"/>
                </a:lnTo>
                <a:lnTo>
                  <a:pt x="4572000" y="2276061"/>
                </a:lnTo>
                <a:lnTo>
                  <a:pt x="0" y="2276061"/>
                </a:lnTo>
                <a:close/>
              </a:path>
            </a:pathLst>
          </a:cu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42" name="ZoneTexte 41"/>
          <p:cNvSpPr txBox="1"/>
          <p:nvPr/>
        </p:nvSpPr>
        <p:spPr>
          <a:xfrm>
            <a:off x="4909268" y="3208546"/>
            <a:ext cx="80878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fr-FR" sz="1600" i="1" dirty="0"/>
              <a:t>AUC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7983360" y="4922137"/>
            <a:ext cx="17614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Time (minutes)</a:t>
            </a:r>
          </a:p>
        </p:txBody>
      </p:sp>
      <p:sp>
        <p:nvSpPr>
          <p:cNvPr id="5" name="Rectangle 4"/>
          <p:cNvSpPr/>
          <p:nvPr/>
        </p:nvSpPr>
        <p:spPr>
          <a:xfrm>
            <a:off x="10795053" y="4846314"/>
            <a:ext cx="1187681" cy="29232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D33EE58-FFA5-EC44-BDAE-FE7BCDDB5679}"/>
              </a:ext>
            </a:extLst>
          </p:cNvPr>
          <p:cNvSpPr/>
          <p:nvPr/>
        </p:nvSpPr>
        <p:spPr>
          <a:xfrm>
            <a:off x="9144000" y="2137443"/>
            <a:ext cx="2588821" cy="337884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78633611-547A-3D45-8062-721F7CA903C6}"/>
              </a:ext>
            </a:extLst>
          </p:cNvPr>
          <p:cNvSpPr txBox="1"/>
          <p:nvPr/>
        </p:nvSpPr>
        <p:spPr>
          <a:xfrm>
            <a:off x="101970" y="146653"/>
            <a:ext cx="3721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l</a:t>
            </a:r>
            <a:r>
              <a:rPr lang="fr-FR" dirty="0"/>
              <a:t> Digital content-Figure 1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69113B5F-521B-5446-ADFA-B9F304FF44EA}"/>
              </a:ext>
            </a:extLst>
          </p:cNvPr>
          <p:cNvSpPr txBox="1"/>
          <p:nvPr/>
        </p:nvSpPr>
        <p:spPr>
          <a:xfrm>
            <a:off x="165100" y="5981700"/>
            <a:ext cx="11811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upplemental</a:t>
            </a:r>
            <a:r>
              <a:rPr lang="fr-FR" sz="1400" b="1" dirty="0"/>
              <a:t> Digital Content-</a:t>
            </a:r>
            <a:r>
              <a:rPr lang="fr-FR" sz="1400" b="1" dirty="0">
                <a:latin typeface="Arial" pitchFamily="34" charset="0"/>
                <a:cs typeface="Arial" pitchFamily="34" charset="0"/>
              </a:rPr>
              <a:t>Figure 1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.Typical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recording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of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microvascular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skin blood flow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recorded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by laser doppler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flowmetry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baseline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and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following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3 successives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iontophoretic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applications of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Acetylcholine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(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Healthy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volunteer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). AUC, area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under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curve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Ach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Acetylcholine</a:t>
            </a:r>
            <a:endParaRPr lang="fr-FR" sz="1400" dirty="0">
              <a:latin typeface="Arial" pitchFamily="34" charset="0"/>
              <a:cs typeface="Arial" pitchFamily="34" charset="0"/>
            </a:endParaRPr>
          </a:p>
          <a:p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2656753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2" grpId="0" animBg="1"/>
      <p:bldP spid="41" grpId="0" animBg="1"/>
      <p:bldP spid="42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../../../../../../Desktop/Capture%20d’écran%202018-10-16%20à%2011.45">
            <a:extLst>
              <a:ext uri="{FF2B5EF4-FFF2-40B4-BE49-F238E27FC236}">
                <a16:creationId xmlns:a16="http://schemas.microsoft.com/office/drawing/2014/main" id="{75357C4B-F868-4F4B-B947-C4F484CCCC5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8984" y="1662546"/>
            <a:ext cx="4370611" cy="3726836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91D69D86-C722-D948-9239-74958C2DDE76}"/>
              </a:ext>
            </a:extLst>
          </p:cNvPr>
          <p:cNvSpPr txBox="1"/>
          <p:nvPr/>
        </p:nvSpPr>
        <p:spPr>
          <a:xfrm>
            <a:off x="101970" y="146653"/>
            <a:ext cx="37860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l</a:t>
            </a:r>
            <a:r>
              <a:rPr lang="fr-FR" dirty="0"/>
              <a:t> Digital content-Figure 2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E00C3A33-628D-CA47-8592-2F440A6E1729}"/>
              </a:ext>
            </a:extLst>
          </p:cNvPr>
          <p:cNvSpPr txBox="1"/>
          <p:nvPr/>
        </p:nvSpPr>
        <p:spPr>
          <a:xfrm>
            <a:off x="165100" y="5981700"/>
            <a:ext cx="11811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itchFamily="34" charset="0"/>
                <a:cs typeface="Arial" pitchFamily="34" charset="0"/>
              </a:rPr>
              <a:t>Supplemental</a:t>
            </a:r>
            <a:r>
              <a:rPr lang="fr-FR" sz="1400" b="1" dirty="0">
                <a:latin typeface="Arial" pitchFamily="34" charset="0"/>
                <a:cs typeface="Arial" pitchFamily="34" charset="0"/>
              </a:rPr>
              <a:t> Digital content-Figure 2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.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Characterization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of RBC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microparticles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by flow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cytometry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after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gating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on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small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size particules (&lt;1</a:t>
            </a:r>
            <a:r>
              <a:rPr lang="en-US" dirty="0" err="1"/>
              <a:t>μ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m).</a:t>
            </a:r>
          </a:p>
          <a:p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1778877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C479EFDF-81BC-DE43-BE42-7CE856DA3830}"/>
              </a:ext>
            </a:extLst>
          </p:cNvPr>
          <p:cNvSpPr txBox="1"/>
          <p:nvPr/>
        </p:nvSpPr>
        <p:spPr>
          <a:xfrm>
            <a:off x="101970" y="146653"/>
            <a:ext cx="3721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l</a:t>
            </a:r>
            <a:r>
              <a:rPr lang="fr-FR" dirty="0"/>
              <a:t> Digital content-Figure 3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0F530456-5E3E-DB41-B6FB-BFC349EEA37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32558"/>
          <a:stretch/>
        </p:blipFill>
        <p:spPr>
          <a:xfrm>
            <a:off x="2100262" y="752474"/>
            <a:ext cx="6134100" cy="441960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466C317E-6F92-8943-B71D-A5F913A762E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320" t="68750" r="27329"/>
          <a:stretch/>
        </p:blipFill>
        <p:spPr>
          <a:xfrm>
            <a:off x="8234362" y="1757362"/>
            <a:ext cx="2843212" cy="204787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5B3760E3-98C6-9B42-95B8-381E13374FCF}"/>
              </a:ext>
            </a:extLst>
          </p:cNvPr>
          <p:cNvSpPr txBox="1"/>
          <p:nvPr/>
        </p:nvSpPr>
        <p:spPr>
          <a:xfrm>
            <a:off x="165100" y="5981700"/>
            <a:ext cx="11811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itchFamily="34" charset="0"/>
                <a:cs typeface="Arial" pitchFamily="34" charset="0"/>
              </a:rPr>
              <a:t>Supplemental</a:t>
            </a:r>
            <a:r>
              <a:rPr lang="fr-FR" sz="1400" b="1" dirty="0">
                <a:latin typeface="Arial" pitchFamily="34" charset="0"/>
                <a:cs typeface="Arial" pitchFamily="34" charset="0"/>
              </a:rPr>
              <a:t> Digital content-Figure 3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. Baseline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leukocyte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subset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count in the blood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according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to variation of microvascular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reactivity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after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RCB transfusion.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Expressed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as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median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(1IQR-3IQR). *, P&lt;0.05; **, P&lt;0.01.</a:t>
            </a:r>
          </a:p>
          <a:p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34563144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6A5E58C8-598E-3648-B1AB-5504A97D07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8561" y="1236528"/>
            <a:ext cx="8327959" cy="3619324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CE7951DB-E101-0848-8A29-4521576D5DC0}"/>
              </a:ext>
            </a:extLst>
          </p:cNvPr>
          <p:cNvSpPr txBox="1"/>
          <p:nvPr/>
        </p:nvSpPr>
        <p:spPr>
          <a:xfrm>
            <a:off x="101970" y="146653"/>
            <a:ext cx="3721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l</a:t>
            </a:r>
            <a:r>
              <a:rPr lang="fr-FR" dirty="0"/>
              <a:t> Digital content-Figure 4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F2E91909-8C2E-E24B-AC6C-D1CA01173F98}"/>
              </a:ext>
            </a:extLst>
          </p:cNvPr>
          <p:cNvSpPr txBox="1"/>
          <p:nvPr/>
        </p:nvSpPr>
        <p:spPr>
          <a:xfrm>
            <a:off x="165100" y="5981700"/>
            <a:ext cx="11811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upplemental</a:t>
            </a:r>
            <a:r>
              <a:rPr lang="fr-FR" sz="1400" b="1" dirty="0"/>
              <a:t> Digital Content-</a:t>
            </a:r>
            <a:r>
              <a:rPr lang="fr-FR" sz="1400" b="1" dirty="0">
                <a:latin typeface="Arial" pitchFamily="34" charset="0"/>
                <a:cs typeface="Arial" pitchFamily="34" charset="0"/>
              </a:rPr>
              <a:t>Figure 4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. A,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Correlation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between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baseline blood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leukocyte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count and variations of microvascular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reactivity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after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RBC transfusion. B,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Correlation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between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baseline blood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platelet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count and variations of microvascular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reactivity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after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RBC transfusion.</a:t>
            </a:r>
          </a:p>
          <a:p>
            <a:endParaRPr lang="fr-FR" sz="1400" dirty="0">
              <a:latin typeface="Arial" pitchFamily="34" charset="0"/>
              <a:cs typeface="Arial" pitchFamily="34" charset="0"/>
            </a:endParaRPr>
          </a:p>
          <a:p>
            <a:endParaRPr lang="fr-FR" sz="1400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DEB54FA-858D-B747-AF56-C67A85B26EB2}"/>
              </a:ext>
            </a:extLst>
          </p:cNvPr>
          <p:cNvSpPr txBox="1"/>
          <p:nvPr/>
        </p:nvSpPr>
        <p:spPr>
          <a:xfrm>
            <a:off x="1885866" y="111777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99ED4344-A455-7445-89EF-D8D170ADCB31}"/>
              </a:ext>
            </a:extLst>
          </p:cNvPr>
          <p:cNvSpPr txBox="1"/>
          <p:nvPr/>
        </p:nvSpPr>
        <p:spPr>
          <a:xfrm>
            <a:off x="6317672" y="111777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864621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4E899140-E220-9E4B-B7BF-6D4E6AAB036E}"/>
              </a:ext>
            </a:extLst>
          </p:cNvPr>
          <p:cNvSpPr txBox="1"/>
          <p:nvPr/>
        </p:nvSpPr>
        <p:spPr>
          <a:xfrm>
            <a:off x="101970" y="146653"/>
            <a:ext cx="3721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l</a:t>
            </a:r>
            <a:r>
              <a:rPr lang="fr-FR" dirty="0"/>
              <a:t> Digital content-Figure 5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7966B687-A6D4-8C40-9942-AD4F76DAFC71}"/>
              </a:ext>
            </a:extLst>
          </p:cNvPr>
          <p:cNvSpPr txBox="1"/>
          <p:nvPr/>
        </p:nvSpPr>
        <p:spPr>
          <a:xfrm>
            <a:off x="165100" y="5981700"/>
            <a:ext cx="11811000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>
                <a:latin typeface="Arial" pitchFamily="34" charset="0"/>
                <a:cs typeface="Arial" pitchFamily="34" charset="0"/>
              </a:rPr>
              <a:t>Supplemental</a:t>
            </a:r>
            <a:r>
              <a:rPr lang="fr-FR" sz="1400" b="1" dirty="0">
                <a:latin typeface="Arial" pitchFamily="34" charset="0"/>
                <a:cs typeface="Arial" pitchFamily="34" charset="0"/>
              </a:rPr>
              <a:t> Digital content-Figure 5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.Quantification of IFN-</a:t>
            </a:r>
            <a:r>
              <a:rPr lang="en-US" dirty="0">
                <a:sym typeface="Symbol" pitchFamily="2" charset="2"/>
              </a:rPr>
              <a:t>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plasma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levels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in patients at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baseline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,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just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before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RBC transfusion. Quantification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was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performed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using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Procartaplex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method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.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Expressed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as </a:t>
            </a:r>
            <a:r>
              <a:rPr lang="fr-FR" sz="1400" dirty="0" err="1">
                <a:latin typeface="Arial" pitchFamily="34" charset="0"/>
                <a:cs typeface="Arial" pitchFamily="34" charset="0"/>
              </a:rPr>
              <a:t>median</a:t>
            </a:r>
            <a:r>
              <a:rPr lang="fr-FR" sz="1400" dirty="0">
                <a:latin typeface="Arial" pitchFamily="34" charset="0"/>
                <a:cs typeface="Arial" pitchFamily="34" charset="0"/>
              </a:rPr>
              <a:t> (1IQR-3IQR). **, P&lt;0.01</a:t>
            </a:r>
          </a:p>
          <a:p>
            <a:endParaRPr lang="fr-FR" sz="1400" dirty="0"/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7819407C-9B74-A344-903F-DDB957E5E3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57650" y="1816100"/>
            <a:ext cx="4076700" cy="3225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133424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</TotalTime>
  <Words>234</Words>
  <Application>Microsoft Macintosh PowerPoint</Application>
  <PresentationFormat>Grand écran</PresentationFormat>
  <Paragraphs>37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22</cp:revision>
  <dcterms:created xsi:type="dcterms:W3CDTF">2018-10-22T16:27:47Z</dcterms:created>
  <dcterms:modified xsi:type="dcterms:W3CDTF">2019-07-29T13:29:48Z</dcterms:modified>
</cp:coreProperties>
</file>